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2519363" cy="2879725"/>
  <p:notesSz cx="6858000" cy="9144000"/>
  <p:defaultTextStyle>
    <a:defPPr>
      <a:defRPr lang="en-US"/>
    </a:defPPr>
    <a:lvl1pPr marL="0" algn="l" defTabSz="259141" rtl="0" eaLnBrk="1" latinLnBrk="0" hangingPunct="1">
      <a:defRPr sz="510" kern="1200">
        <a:solidFill>
          <a:schemeClr val="tx1"/>
        </a:solidFill>
        <a:latin typeface="+mn-lt"/>
        <a:ea typeface="+mn-ea"/>
        <a:cs typeface="+mn-cs"/>
      </a:defRPr>
    </a:lvl1pPr>
    <a:lvl2pPr marL="129570" algn="l" defTabSz="259141" rtl="0" eaLnBrk="1" latinLnBrk="0" hangingPunct="1">
      <a:defRPr sz="510" kern="1200">
        <a:solidFill>
          <a:schemeClr val="tx1"/>
        </a:solidFill>
        <a:latin typeface="+mn-lt"/>
        <a:ea typeface="+mn-ea"/>
        <a:cs typeface="+mn-cs"/>
      </a:defRPr>
    </a:lvl2pPr>
    <a:lvl3pPr marL="259141" algn="l" defTabSz="259141" rtl="0" eaLnBrk="1" latinLnBrk="0" hangingPunct="1">
      <a:defRPr sz="510" kern="1200">
        <a:solidFill>
          <a:schemeClr val="tx1"/>
        </a:solidFill>
        <a:latin typeface="+mn-lt"/>
        <a:ea typeface="+mn-ea"/>
        <a:cs typeface="+mn-cs"/>
      </a:defRPr>
    </a:lvl3pPr>
    <a:lvl4pPr marL="388711" algn="l" defTabSz="259141" rtl="0" eaLnBrk="1" latinLnBrk="0" hangingPunct="1">
      <a:defRPr sz="510" kern="1200">
        <a:solidFill>
          <a:schemeClr val="tx1"/>
        </a:solidFill>
        <a:latin typeface="+mn-lt"/>
        <a:ea typeface="+mn-ea"/>
        <a:cs typeface="+mn-cs"/>
      </a:defRPr>
    </a:lvl4pPr>
    <a:lvl5pPr marL="518282" algn="l" defTabSz="259141" rtl="0" eaLnBrk="1" latinLnBrk="0" hangingPunct="1">
      <a:defRPr sz="510" kern="1200">
        <a:solidFill>
          <a:schemeClr val="tx1"/>
        </a:solidFill>
        <a:latin typeface="+mn-lt"/>
        <a:ea typeface="+mn-ea"/>
        <a:cs typeface="+mn-cs"/>
      </a:defRPr>
    </a:lvl5pPr>
    <a:lvl6pPr marL="647852" algn="l" defTabSz="259141" rtl="0" eaLnBrk="1" latinLnBrk="0" hangingPunct="1">
      <a:defRPr sz="510" kern="1200">
        <a:solidFill>
          <a:schemeClr val="tx1"/>
        </a:solidFill>
        <a:latin typeface="+mn-lt"/>
        <a:ea typeface="+mn-ea"/>
        <a:cs typeface="+mn-cs"/>
      </a:defRPr>
    </a:lvl6pPr>
    <a:lvl7pPr marL="777423" algn="l" defTabSz="259141" rtl="0" eaLnBrk="1" latinLnBrk="0" hangingPunct="1">
      <a:defRPr sz="510" kern="1200">
        <a:solidFill>
          <a:schemeClr val="tx1"/>
        </a:solidFill>
        <a:latin typeface="+mn-lt"/>
        <a:ea typeface="+mn-ea"/>
        <a:cs typeface="+mn-cs"/>
      </a:defRPr>
    </a:lvl7pPr>
    <a:lvl8pPr marL="906993" algn="l" defTabSz="259141" rtl="0" eaLnBrk="1" latinLnBrk="0" hangingPunct="1">
      <a:defRPr sz="510" kern="1200">
        <a:solidFill>
          <a:schemeClr val="tx1"/>
        </a:solidFill>
        <a:latin typeface="+mn-lt"/>
        <a:ea typeface="+mn-ea"/>
        <a:cs typeface="+mn-cs"/>
      </a:defRPr>
    </a:lvl8pPr>
    <a:lvl9pPr marL="1036564" algn="l" defTabSz="259141" rtl="0" eaLnBrk="1" latinLnBrk="0" hangingPunct="1">
      <a:defRPr sz="51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82" autoAdjust="0"/>
    <p:restoredTop sz="94660"/>
  </p:normalViewPr>
  <p:slideViewPr>
    <p:cSldViewPr snapToGrid="0">
      <p:cViewPr varScale="1">
        <p:scale>
          <a:sx n="166" d="100"/>
          <a:sy n="166" d="100"/>
        </p:scale>
        <p:origin x="-2334" y="-90"/>
      </p:cViewPr>
      <p:guideLst>
        <p:guide orient="horz" pos="907"/>
        <p:guide pos="79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8952" y="471289"/>
            <a:ext cx="2141459" cy="1002571"/>
          </a:xfrm>
        </p:spPr>
        <p:txBody>
          <a:bodyPr anchor="b"/>
          <a:lstStyle>
            <a:lvl1pPr algn="ctr">
              <a:defRPr sz="165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4921" y="1512522"/>
            <a:ext cx="1889522" cy="695267"/>
          </a:xfrm>
        </p:spPr>
        <p:txBody>
          <a:bodyPr/>
          <a:lstStyle>
            <a:lvl1pPr marL="0" indent="0" algn="ctr">
              <a:buNone/>
              <a:defRPr sz="661"/>
            </a:lvl1pPr>
            <a:lvl2pPr marL="125959" indent="0" algn="ctr">
              <a:buNone/>
              <a:defRPr sz="551"/>
            </a:lvl2pPr>
            <a:lvl3pPr marL="251917" indent="0" algn="ctr">
              <a:buNone/>
              <a:defRPr sz="496"/>
            </a:lvl3pPr>
            <a:lvl4pPr marL="377876" indent="0" algn="ctr">
              <a:buNone/>
              <a:defRPr sz="441"/>
            </a:lvl4pPr>
            <a:lvl5pPr marL="503834" indent="0" algn="ctr">
              <a:buNone/>
              <a:defRPr sz="441"/>
            </a:lvl5pPr>
            <a:lvl6pPr marL="629793" indent="0" algn="ctr">
              <a:buNone/>
              <a:defRPr sz="441"/>
            </a:lvl6pPr>
            <a:lvl7pPr marL="755752" indent="0" algn="ctr">
              <a:buNone/>
              <a:defRPr sz="441"/>
            </a:lvl7pPr>
            <a:lvl8pPr marL="881710" indent="0" algn="ctr">
              <a:buNone/>
              <a:defRPr sz="441"/>
            </a:lvl8pPr>
            <a:lvl9pPr marL="1007669" indent="0" algn="ctr">
              <a:buNone/>
              <a:defRPr sz="441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488216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305775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02919" y="153319"/>
            <a:ext cx="543238" cy="244043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3206" y="153319"/>
            <a:ext cx="1598221" cy="244043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283103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667749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894" y="717932"/>
            <a:ext cx="2172951" cy="1197885"/>
          </a:xfrm>
        </p:spPr>
        <p:txBody>
          <a:bodyPr anchor="b"/>
          <a:lstStyle>
            <a:lvl1pPr>
              <a:defRPr sz="165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894" y="1927150"/>
            <a:ext cx="2172951" cy="629940"/>
          </a:xfrm>
        </p:spPr>
        <p:txBody>
          <a:bodyPr/>
          <a:lstStyle>
            <a:lvl1pPr marL="0" indent="0">
              <a:buNone/>
              <a:defRPr sz="661">
                <a:solidFill>
                  <a:schemeClr val="tx1"/>
                </a:solidFill>
              </a:defRPr>
            </a:lvl1pPr>
            <a:lvl2pPr marL="125959" indent="0">
              <a:buNone/>
              <a:defRPr sz="551">
                <a:solidFill>
                  <a:schemeClr val="tx1">
                    <a:tint val="75000"/>
                  </a:schemeClr>
                </a:solidFill>
              </a:defRPr>
            </a:lvl2pPr>
            <a:lvl3pPr marL="251917" indent="0">
              <a:buNone/>
              <a:defRPr sz="496">
                <a:solidFill>
                  <a:schemeClr val="tx1">
                    <a:tint val="75000"/>
                  </a:schemeClr>
                </a:solidFill>
              </a:defRPr>
            </a:lvl3pPr>
            <a:lvl4pPr marL="377876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4pPr>
            <a:lvl5pPr marL="503834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5pPr>
            <a:lvl6pPr marL="629793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6pPr>
            <a:lvl7pPr marL="755752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7pPr>
            <a:lvl8pPr marL="881710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8pPr>
            <a:lvl9pPr marL="1007669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4183066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3206" y="766593"/>
            <a:ext cx="1070729" cy="182715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75428" y="766593"/>
            <a:ext cx="1070729" cy="182715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524260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34" y="153319"/>
            <a:ext cx="2172951" cy="55661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535" y="705933"/>
            <a:ext cx="1065808" cy="345967"/>
          </a:xfrm>
        </p:spPr>
        <p:txBody>
          <a:bodyPr anchor="b"/>
          <a:lstStyle>
            <a:lvl1pPr marL="0" indent="0">
              <a:buNone/>
              <a:defRPr sz="661" b="1"/>
            </a:lvl1pPr>
            <a:lvl2pPr marL="125959" indent="0">
              <a:buNone/>
              <a:defRPr sz="551" b="1"/>
            </a:lvl2pPr>
            <a:lvl3pPr marL="251917" indent="0">
              <a:buNone/>
              <a:defRPr sz="496" b="1"/>
            </a:lvl3pPr>
            <a:lvl4pPr marL="377876" indent="0">
              <a:buNone/>
              <a:defRPr sz="441" b="1"/>
            </a:lvl4pPr>
            <a:lvl5pPr marL="503834" indent="0">
              <a:buNone/>
              <a:defRPr sz="441" b="1"/>
            </a:lvl5pPr>
            <a:lvl6pPr marL="629793" indent="0">
              <a:buNone/>
              <a:defRPr sz="441" b="1"/>
            </a:lvl6pPr>
            <a:lvl7pPr marL="755752" indent="0">
              <a:buNone/>
              <a:defRPr sz="441" b="1"/>
            </a:lvl7pPr>
            <a:lvl8pPr marL="881710" indent="0">
              <a:buNone/>
              <a:defRPr sz="441" b="1"/>
            </a:lvl8pPr>
            <a:lvl9pPr marL="1007669" indent="0">
              <a:buNone/>
              <a:defRPr sz="44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535" y="1051899"/>
            <a:ext cx="1065808" cy="154718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75428" y="705933"/>
            <a:ext cx="1071057" cy="345967"/>
          </a:xfrm>
        </p:spPr>
        <p:txBody>
          <a:bodyPr anchor="b"/>
          <a:lstStyle>
            <a:lvl1pPr marL="0" indent="0">
              <a:buNone/>
              <a:defRPr sz="661" b="1"/>
            </a:lvl1pPr>
            <a:lvl2pPr marL="125959" indent="0">
              <a:buNone/>
              <a:defRPr sz="551" b="1"/>
            </a:lvl2pPr>
            <a:lvl3pPr marL="251917" indent="0">
              <a:buNone/>
              <a:defRPr sz="496" b="1"/>
            </a:lvl3pPr>
            <a:lvl4pPr marL="377876" indent="0">
              <a:buNone/>
              <a:defRPr sz="441" b="1"/>
            </a:lvl4pPr>
            <a:lvl5pPr marL="503834" indent="0">
              <a:buNone/>
              <a:defRPr sz="441" b="1"/>
            </a:lvl5pPr>
            <a:lvl6pPr marL="629793" indent="0">
              <a:buNone/>
              <a:defRPr sz="441" b="1"/>
            </a:lvl6pPr>
            <a:lvl7pPr marL="755752" indent="0">
              <a:buNone/>
              <a:defRPr sz="441" b="1"/>
            </a:lvl7pPr>
            <a:lvl8pPr marL="881710" indent="0">
              <a:buNone/>
              <a:defRPr sz="441" b="1"/>
            </a:lvl8pPr>
            <a:lvl9pPr marL="1007669" indent="0">
              <a:buNone/>
              <a:defRPr sz="44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75428" y="1051899"/>
            <a:ext cx="1071057" cy="154718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459604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4216048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863238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34" y="191982"/>
            <a:ext cx="812560" cy="671936"/>
          </a:xfrm>
        </p:spPr>
        <p:txBody>
          <a:bodyPr anchor="b"/>
          <a:lstStyle>
            <a:lvl1pPr>
              <a:defRPr sz="88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1057" y="414628"/>
            <a:ext cx="1275428" cy="2046471"/>
          </a:xfrm>
        </p:spPr>
        <p:txBody>
          <a:bodyPr/>
          <a:lstStyle>
            <a:lvl1pPr>
              <a:defRPr sz="882"/>
            </a:lvl1pPr>
            <a:lvl2pPr>
              <a:defRPr sz="771"/>
            </a:lvl2pPr>
            <a:lvl3pPr>
              <a:defRPr sz="661"/>
            </a:lvl3pPr>
            <a:lvl4pPr>
              <a:defRPr sz="551"/>
            </a:lvl4pPr>
            <a:lvl5pPr>
              <a:defRPr sz="551"/>
            </a:lvl5pPr>
            <a:lvl6pPr>
              <a:defRPr sz="551"/>
            </a:lvl6pPr>
            <a:lvl7pPr>
              <a:defRPr sz="551"/>
            </a:lvl7pPr>
            <a:lvl8pPr>
              <a:defRPr sz="551"/>
            </a:lvl8pPr>
            <a:lvl9pPr>
              <a:defRPr sz="551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34" y="863918"/>
            <a:ext cx="812560" cy="1600514"/>
          </a:xfrm>
        </p:spPr>
        <p:txBody>
          <a:bodyPr/>
          <a:lstStyle>
            <a:lvl1pPr marL="0" indent="0">
              <a:buNone/>
              <a:defRPr sz="441"/>
            </a:lvl1pPr>
            <a:lvl2pPr marL="125959" indent="0">
              <a:buNone/>
              <a:defRPr sz="386"/>
            </a:lvl2pPr>
            <a:lvl3pPr marL="251917" indent="0">
              <a:buNone/>
              <a:defRPr sz="331"/>
            </a:lvl3pPr>
            <a:lvl4pPr marL="377876" indent="0">
              <a:buNone/>
              <a:defRPr sz="276"/>
            </a:lvl4pPr>
            <a:lvl5pPr marL="503834" indent="0">
              <a:buNone/>
              <a:defRPr sz="276"/>
            </a:lvl5pPr>
            <a:lvl6pPr marL="629793" indent="0">
              <a:buNone/>
              <a:defRPr sz="276"/>
            </a:lvl6pPr>
            <a:lvl7pPr marL="755752" indent="0">
              <a:buNone/>
              <a:defRPr sz="276"/>
            </a:lvl7pPr>
            <a:lvl8pPr marL="881710" indent="0">
              <a:buNone/>
              <a:defRPr sz="276"/>
            </a:lvl8pPr>
            <a:lvl9pPr marL="1007669" indent="0">
              <a:buNone/>
              <a:defRPr sz="27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4015603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34" y="191982"/>
            <a:ext cx="812560" cy="671936"/>
          </a:xfrm>
        </p:spPr>
        <p:txBody>
          <a:bodyPr anchor="b"/>
          <a:lstStyle>
            <a:lvl1pPr>
              <a:defRPr sz="88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71057" y="414628"/>
            <a:ext cx="1275428" cy="2046471"/>
          </a:xfrm>
        </p:spPr>
        <p:txBody>
          <a:bodyPr anchor="t"/>
          <a:lstStyle>
            <a:lvl1pPr marL="0" indent="0">
              <a:buNone/>
              <a:defRPr sz="882"/>
            </a:lvl1pPr>
            <a:lvl2pPr marL="125959" indent="0">
              <a:buNone/>
              <a:defRPr sz="771"/>
            </a:lvl2pPr>
            <a:lvl3pPr marL="251917" indent="0">
              <a:buNone/>
              <a:defRPr sz="661"/>
            </a:lvl3pPr>
            <a:lvl4pPr marL="377876" indent="0">
              <a:buNone/>
              <a:defRPr sz="551"/>
            </a:lvl4pPr>
            <a:lvl5pPr marL="503834" indent="0">
              <a:buNone/>
              <a:defRPr sz="551"/>
            </a:lvl5pPr>
            <a:lvl6pPr marL="629793" indent="0">
              <a:buNone/>
              <a:defRPr sz="551"/>
            </a:lvl6pPr>
            <a:lvl7pPr marL="755752" indent="0">
              <a:buNone/>
              <a:defRPr sz="551"/>
            </a:lvl7pPr>
            <a:lvl8pPr marL="881710" indent="0">
              <a:buNone/>
              <a:defRPr sz="551"/>
            </a:lvl8pPr>
            <a:lvl9pPr marL="1007669" indent="0">
              <a:buNone/>
              <a:defRPr sz="551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34" y="863918"/>
            <a:ext cx="812560" cy="1600514"/>
          </a:xfrm>
        </p:spPr>
        <p:txBody>
          <a:bodyPr/>
          <a:lstStyle>
            <a:lvl1pPr marL="0" indent="0">
              <a:buNone/>
              <a:defRPr sz="441"/>
            </a:lvl1pPr>
            <a:lvl2pPr marL="125959" indent="0">
              <a:buNone/>
              <a:defRPr sz="386"/>
            </a:lvl2pPr>
            <a:lvl3pPr marL="251917" indent="0">
              <a:buNone/>
              <a:defRPr sz="331"/>
            </a:lvl3pPr>
            <a:lvl4pPr marL="377876" indent="0">
              <a:buNone/>
              <a:defRPr sz="276"/>
            </a:lvl4pPr>
            <a:lvl5pPr marL="503834" indent="0">
              <a:buNone/>
              <a:defRPr sz="276"/>
            </a:lvl5pPr>
            <a:lvl6pPr marL="629793" indent="0">
              <a:buNone/>
              <a:defRPr sz="276"/>
            </a:lvl6pPr>
            <a:lvl7pPr marL="755752" indent="0">
              <a:buNone/>
              <a:defRPr sz="276"/>
            </a:lvl7pPr>
            <a:lvl8pPr marL="881710" indent="0">
              <a:buNone/>
              <a:defRPr sz="276"/>
            </a:lvl8pPr>
            <a:lvl9pPr marL="1007669" indent="0">
              <a:buNone/>
              <a:defRPr sz="27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787271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3206" y="153319"/>
            <a:ext cx="2172951" cy="5566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206" y="766593"/>
            <a:ext cx="2172951" cy="18271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3206" y="2669079"/>
            <a:ext cx="566857" cy="153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F866A-0326-42AA-AA6D-E0980DD07859}" type="datetimeFigureOut">
              <a:rPr lang="en-IN" smtClean="0"/>
              <a:pPr/>
              <a:t>08-08-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34539" y="2669079"/>
            <a:ext cx="850285" cy="153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79300" y="2669079"/>
            <a:ext cx="566857" cy="153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01DCAD-EF9A-4328-B63B-F896AE4A665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68114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51917" rtl="0" eaLnBrk="1" latinLnBrk="0" hangingPunct="1">
        <a:lnSpc>
          <a:spcPct val="90000"/>
        </a:lnSpc>
        <a:spcBef>
          <a:spcPct val="0"/>
        </a:spcBef>
        <a:buNone/>
        <a:defRPr sz="12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2979" indent="-62979" algn="l" defTabSz="2519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771" kern="1200">
          <a:solidFill>
            <a:schemeClr val="tx1"/>
          </a:solidFill>
          <a:latin typeface="+mn-lt"/>
          <a:ea typeface="+mn-ea"/>
          <a:cs typeface="+mn-cs"/>
        </a:defRPr>
      </a:lvl1pPr>
      <a:lvl2pPr marL="188938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661" kern="1200">
          <a:solidFill>
            <a:schemeClr val="tx1"/>
          </a:solidFill>
          <a:latin typeface="+mn-lt"/>
          <a:ea typeface="+mn-ea"/>
          <a:cs typeface="+mn-cs"/>
        </a:defRPr>
      </a:lvl2pPr>
      <a:lvl3pPr marL="314897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551" kern="1200">
          <a:solidFill>
            <a:schemeClr val="tx1"/>
          </a:solidFill>
          <a:latin typeface="+mn-lt"/>
          <a:ea typeface="+mn-ea"/>
          <a:cs typeface="+mn-cs"/>
        </a:defRPr>
      </a:lvl3pPr>
      <a:lvl4pPr marL="440855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4pPr>
      <a:lvl5pPr marL="566814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5pPr>
      <a:lvl6pPr marL="692772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6pPr>
      <a:lvl7pPr marL="818731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7pPr>
      <a:lvl8pPr marL="944690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8pPr>
      <a:lvl9pPr marL="1070648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1pPr>
      <a:lvl2pPr marL="125959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2pPr>
      <a:lvl3pPr marL="251917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3pPr>
      <a:lvl4pPr marL="377876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4pPr>
      <a:lvl5pPr marL="503834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5pPr>
      <a:lvl6pPr marL="629793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6pPr>
      <a:lvl7pPr marL="755752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7pPr>
      <a:lvl8pPr marL="881710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8pPr>
      <a:lvl9pPr marL="1007669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03866" y="-22441"/>
            <a:ext cx="1465094" cy="1696007"/>
            <a:chOff x="303866" y="493663"/>
            <a:chExt cx="1465094" cy="1696007"/>
          </a:xfrm>
        </p:grpSpPr>
        <p:cxnSp>
          <p:nvCxnSpPr>
            <p:cNvPr id="14" name="Straight Connector 13"/>
            <p:cNvCxnSpPr/>
            <p:nvPr/>
          </p:nvCxnSpPr>
          <p:spPr>
            <a:xfrm flipV="1">
              <a:off x="746993" y="1631148"/>
              <a:ext cx="10209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 flipV="1">
              <a:off x="747974" y="1761909"/>
              <a:ext cx="10209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 flipV="1">
              <a:off x="747040" y="1352906"/>
              <a:ext cx="10209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 flipV="1">
              <a:off x="746105" y="1093916"/>
              <a:ext cx="10209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816197" y="690054"/>
              <a:ext cx="886968" cy="149961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308540" y="959278"/>
              <a:ext cx="5212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IN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03866" y="1229487"/>
              <a:ext cx="5212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I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IN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10411" y="1662377"/>
              <a:ext cx="5212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 </a:t>
              </a:r>
              <a:r>
                <a:rPr lang="en-IN" sz="9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52689" y="49366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IN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448264" y="494594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312667" y="1513162"/>
              <a:ext cx="5212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 kDa</a:t>
              </a:r>
              <a:endParaRPr lang="en-IN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-39269" y="1699771"/>
            <a:ext cx="255863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performed with the antibody raised against GlRpn10.  Whole cell extracts of 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US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mblia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ophozoite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subjected to SDS-PAGE and probed with either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immune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rum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ane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 or the antibody raised against GlRpn10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ane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).  Use of the antibody resulted in the detection of a band corresponding to the predicted size of GlRpn10 (28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 This band was not observed when pre-immune serum was used.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64708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89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banita</dc:creator>
  <cp:lastModifiedBy>SrimontiSarkar</cp:lastModifiedBy>
  <cp:revision>4</cp:revision>
  <dcterms:created xsi:type="dcterms:W3CDTF">2014-07-16T09:41:01Z</dcterms:created>
  <dcterms:modified xsi:type="dcterms:W3CDTF">2014-08-08T12:54:22Z</dcterms:modified>
</cp:coreProperties>
</file>